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2" r:id="rId2"/>
    <p:sldId id="280" r:id="rId3"/>
    <p:sldId id="281" r:id="rId4"/>
    <p:sldId id="275" r:id="rId5"/>
    <p:sldId id="276" r:id="rId6"/>
    <p:sldId id="277" r:id="rId7"/>
    <p:sldId id="283" r:id="rId8"/>
    <p:sldId id="278" r:id="rId9"/>
    <p:sldId id="284" r:id="rId10"/>
    <p:sldId id="272" r:id="rId11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646" autoAdjust="0"/>
    <p:restoredTop sz="94674"/>
  </p:normalViewPr>
  <p:slideViewPr>
    <p:cSldViewPr>
      <p:cViewPr varScale="1">
        <p:scale>
          <a:sx n="93" d="100"/>
          <a:sy n="93" d="100"/>
        </p:scale>
        <p:origin x="2032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2203\20220318&#28895;&#33609;&#38498;&#65288;&#24464;&#39336;&#65289;\&#21494;&#32511;&#32032;&#21547;&#37327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2203\20220318&#28895;&#33609;&#38498;&#65288;&#24464;&#39336;&#65289;\&#21494;&#32511;&#32032;&#21547;&#37327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2203\20220318&#28895;&#33609;&#38498;&#65288;&#24464;&#39336;&#65289;\&#21494;&#32511;&#32032;&#21547;&#3732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>
              <a:solidFill>
                <a:srgbClr val="00B050"/>
              </a:solidFill>
            </a:ln>
          </c:spPr>
          <c:marker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2:$F$7</c:f>
                <c:numCache>
                  <c:formatCode>General</c:formatCode>
                  <c:ptCount val="6"/>
                  <c:pt idx="0">
                    <c:v>4.0356707370400098E-2</c:v>
                  </c:pt>
                  <c:pt idx="1">
                    <c:v>7.0530168529350803E-2</c:v>
                  </c:pt>
                  <c:pt idx="2">
                    <c:v>9.7734748238032507E-2</c:v>
                  </c:pt>
                  <c:pt idx="3">
                    <c:v>0.10167803842292999</c:v>
                  </c:pt>
                  <c:pt idx="4">
                    <c:v>7.4200291446975195E-2</c:v>
                  </c:pt>
                  <c:pt idx="5">
                    <c:v>3.1649104472311597E-2</c:v>
                  </c:pt>
                </c:numCache>
              </c:numRef>
            </c:plus>
            <c:minus>
              <c:numRef>
                <c:f>Sheet2!$F$2:$F$7</c:f>
                <c:numCache>
                  <c:formatCode>General</c:formatCode>
                  <c:ptCount val="6"/>
                  <c:pt idx="0">
                    <c:v>4.0356707370400098E-2</c:v>
                  </c:pt>
                  <c:pt idx="1">
                    <c:v>7.0530168529350803E-2</c:v>
                  </c:pt>
                  <c:pt idx="2">
                    <c:v>9.7734748238032507E-2</c:v>
                  </c:pt>
                  <c:pt idx="3">
                    <c:v>0.10167803842292999</c:v>
                  </c:pt>
                  <c:pt idx="4">
                    <c:v>7.4200291446975195E-2</c:v>
                  </c:pt>
                  <c:pt idx="5">
                    <c:v>3.1649104472311597E-2</c:v>
                  </c:pt>
                </c:numCache>
              </c:numRef>
            </c:minus>
          </c:errBars>
          <c:cat>
            <c:strRef>
              <c:f>Sheet2!$A$2:$A$7</c:f>
              <c:strCache>
                <c:ptCount val="6"/>
                <c:pt idx="0">
                  <c:v>M1</c:v>
                </c:pt>
                <c:pt idx="1">
                  <c:v>M2</c:v>
                </c:pt>
                <c:pt idx="2">
                  <c:v>M3</c:v>
                </c:pt>
                <c:pt idx="3">
                  <c:v>M4</c:v>
                </c:pt>
                <c:pt idx="4">
                  <c:v>M5</c:v>
                </c:pt>
                <c:pt idx="5">
                  <c:v>M6</c:v>
                </c:pt>
              </c:strCache>
            </c:strRef>
          </c:cat>
          <c:val>
            <c:numRef>
              <c:f>Sheet2!$B$2:$B$7</c:f>
              <c:numCache>
                <c:formatCode>General</c:formatCode>
                <c:ptCount val="6"/>
                <c:pt idx="0">
                  <c:v>1.2338144236760133</c:v>
                </c:pt>
                <c:pt idx="1">
                  <c:v>1.3000859567901235</c:v>
                </c:pt>
                <c:pt idx="2">
                  <c:v>0.93661380952381001</c:v>
                </c:pt>
                <c:pt idx="3">
                  <c:v>0.96514177777777999</c:v>
                </c:pt>
                <c:pt idx="4">
                  <c:v>0.76501560439560434</c:v>
                </c:pt>
                <c:pt idx="5">
                  <c:v>0.5673164174454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ABE-FE42-9B5A-C1E22773A6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0896896"/>
        <c:axId val="125531264"/>
      </c:lineChart>
      <c:catAx>
        <c:axId val="1208968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125531264"/>
        <c:crosses val="autoZero"/>
        <c:auto val="1"/>
        <c:lblAlgn val="ctr"/>
        <c:lblOffset val="100"/>
        <c:noMultiLvlLbl val="0"/>
      </c:catAx>
      <c:valAx>
        <c:axId val="1255312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120896896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>
              <a:solidFill>
                <a:srgbClr val="00B050"/>
              </a:solidFill>
            </a:ln>
          </c:spPr>
          <c:marker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G$2:$G$7</c:f>
                <c:numCache>
                  <c:formatCode>General</c:formatCode>
                  <c:ptCount val="6"/>
                  <c:pt idx="0">
                    <c:v>8.6132942823610795E-2</c:v>
                  </c:pt>
                  <c:pt idx="1">
                    <c:v>1.9261909694117799E-2</c:v>
                  </c:pt>
                  <c:pt idx="2">
                    <c:v>1.8253314941099299E-2</c:v>
                  </c:pt>
                  <c:pt idx="3">
                    <c:v>9.4448164290136007E-3</c:v>
                  </c:pt>
                  <c:pt idx="4">
                    <c:v>6.7009991558912504E-2</c:v>
                  </c:pt>
                  <c:pt idx="5">
                    <c:v>2.3415621338560001E-2</c:v>
                  </c:pt>
                </c:numCache>
              </c:numRef>
            </c:plus>
            <c:minus>
              <c:numRef>
                <c:f>Sheet2!$G$2:$G$7</c:f>
                <c:numCache>
                  <c:formatCode>General</c:formatCode>
                  <c:ptCount val="6"/>
                  <c:pt idx="0">
                    <c:v>8.6132942823610795E-2</c:v>
                  </c:pt>
                  <c:pt idx="1">
                    <c:v>1.9261909694117799E-2</c:v>
                  </c:pt>
                  <c:pt idx="2">
                    <c:v>1.8253314941099299E-2</c:v>
                  </c:pt>
                  <c:pt idx="3">
                    <c:v>9.4448164290136007E-3</c:v>
                  </c:pt>
                  <c:pt idx="4">
                    <c:v>6.7009991558912504E-2</c:v>
                  </c:pt>
                  <c:pt idx="5">
                    <c:v>2.3415621338560001E-2</c:v>
                  </c:pt>
                </c:numCache>
              </c:numRef>
            </c:minus>
          </c:errBars>
          <c:cat>
            <c:strRef>
              <c:f>Sheet2!$A$2:$A$7</c:f>
              <c:strCache>
                <c:ptCount val="6"/>
                <c:pt idx="0">
                  <c:v>M1</c:v>
                </c:pt>
                <c:pt idx="1">
                  <c:v>M2</c:v>
                </c:pt>
                <c:pt idx="2">
                  <c:v>M3</c:v>
                </c:pt>
                <c:pt idx="3">
                  <c:v>M4</c:v>
                </c:pt>
                <c:pt idx="4">
                  <c:v>M5</c:v>
                </c:pt>
                <c:pt idx="5">
                  <c:v>M6</c:v>
                </c:pt>
              </c:strCache>
            </c:strRef>
          </c:cat>
          <c:val>
            <c:numRef>
              <c:f>Sheet2!$C$2:$C$7</c:f>
              <c:numCache>
                <c:formatCode>General</c:formatCode>
                <c:ptCount val="6"/>
                <c:pt idx="0">
                  <c:v>0.79465604361370701</c:v>
                </c:pt>
                <c:pt idx="1">
                  <c:v>0.96385083333333299</c:v>
                </c:pt>
                <c:pt idx="2">
                  <c:v>0.73241746031746036</c:v>
                </c:pt>
                <c:pt idx="3">
                  <c:v>0.8168306666666667</c:v>
                </c:pt>
                <c:pt idx="4">
                  <c:v>0.50617164835164841</c:v>
                </c:pt>
                <c:pt idx="5">
                  <c:v>0.507452523364485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D0F-874A-A9E0-95B2636059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5559552"/>
        <c:axId val="125561088"/>
      </c:lineChart>
      <c:catAx>
        <c:axId val="1255595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125561088"/>
        <c:crosses val="autoZero"/>
        <c:auto val="1"/>
        <c:lblAlgn val="ctr"/>
        <c:lblOffset val="100"/>
        <c:noMultiLvlLbl val="0"/>
      </c:catAx>
      <c:valAx>
        <c:axId val="1255610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125559552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730644605441248"/>
          <c:y val="4.3350208814883801E-2"/>
          <c:w val="0.75545289495825019"/>
          <c:h val="0.82145687422238434"/>
        </c:manualLayout>
      </c:layout>
      <c:lineChart>
        <c:grouping val="standard"/>
        <c:varyColors val="0"/>
        <c:ser>
          <c:idx val="0"/>
          <c:order val="0"/>
          <c:spPr>
            <a:ln>
              <a:solidFill>
                <a:srgbClr val="00B050"/>
              </a:solidFill>
            </a:ln>
          </c:spPr>
          <c:marker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H$2:$H$7</c:f>
                <c:numCache>
                  <c:formatCode>General</c:formatCode>
                  <c:ptCount val="6"/>
                  <c:pt idx="0">
                    <c:v>1.26487242439984E-2</c:v>
                  </c:pt>
                  <c:pt idx="1">
                    <c:v>0.19094310620768101</c:v>
                  </c:pt>
                  <c:pt idx="2">
                    <c:v>2.499363057787763E-2</c:v>
                  </c:pt>
                  <c:pt idx="3">
                    <c:v>9.5978279937818003E-2</c:v>
                  </c:pt>
                  <c:pt idx="4">
                    <c:v>2.21176143845079E-3</c:v>
                  </c:pt>
                  <c:pt idx="5">
                    <c:v>9.7365433897246195E-2</c:v>
                  </c:pt>
                </c:numCache>
              </c:numRef>
            </c:plus>
            <c:minus>
              <c:numRef>
                <c:f>Sheet2!$H$2:$H$7</c:f>
                <c:numCache>
                  <c:formatCode>General</c:formatCode>
                  <c:ptCount val="6"/>
                  <c:pt idx="0">
                    <c:v>1.26487242439984E-2</c:v>
                  </c:pt>
                  <c:pt idx="1">
                    <c:v>0.19094310620768101</c:v>
                  </c:pt>
                  <c:pt idx="2">
                    <c:v>2.499363057787763E-2</c:v>
                  </c:pt>
                  <c:pt idx="3">
                    <c:v>9.5978279937818003E-2</c:v>
                  </c:pt>
                  <c:pt idx="4">
                    <c:v>2.21176143845079E-3</c:v>
                  </c:pt>
                  <c:pt idx="5">
                    <c:v>9.7365433897246195E-2</c:v>
                  </c:pt>
                </c:numCache>
              </c:numRef>
            </c:minus>
          </c:errBars>
          <c:cat>
            <c:strRef>
              <c:f>Sheet2!$A$2:$A$7</c:f>
              <c:strCache>
                <c:ptCount val="6"/>
                <c:pt idx="0">
                  <c:v>M1</c:v>
                </c:pt>
                <c:pt idx="1">
                  <c:v>M2</c:v>
                </c:pt>
                <c:pt idx="2">
                  <c:v>M3</c:v>
                </c:pt>
                <c:pt idx="3">
                  <c:v>M4</c:v>
                </c:pt>
                <c:pt idx="4">
                  <c:v>M5</c:v>
                </c:pt>
                <c:pt idx="5">
                  <c:v>M6</c:v>
                </c:pt>
              </c:strCache>
            </c:strRef>
          </c:cat>
          <c:val>
            <c:numRef>
              <c:f>Sheet2!$D$2:$D$7</c:f>
              <c:numCache>
                <c:formatCode>General</c:formatCode>
                <c:ptCount val="6"/>
                <c:pt idx="0">
                  <c:v>2.0284704672897202</c:v>
                </c:pt>
                <c:pt idx="1">
                  <c:v>2.2639367901234566</c:v>
                </c:pt>
                <c:pt idx="2">
                  <c:v>1.6690312698412704</c:v>
                </c:pt>
                <c:pt idx="3">
                  <c:v>1.7819724444444467</c:v>
                </c:pt>
                <c:pt idx="4">
                  <c:v>1.2711872527472527</c:v>
                </c:pt>
                <c:pt idx="5">
                  <c:v>1.07476894080996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479-9F49-A5DF-C1F984C7AC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9421568"/>
        <c:axId val="139423104"/>
      </c:lineChart>
      <c:catAx>
        <c:axId val="1394215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139423104"/>
        <c:crosses val="autoZero"/>
        <c:auto val="1"/>
        <c:lblAlgn val="ctr"/>
        <c:lblOffset val="100"/>
        <c:noMultiLvlLbl val="0"/>
      </c:catAx>
      <c:valAx>
        <c:axId val="1394231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139421568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3/4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851920" y="6535796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S1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3648" y="552058"/>
            <a:ext cx="6074296" cy="58606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2397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4351962" y="6412686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Figure S1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J:\0409\figure8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3825" y="836712"/>
            <a:ext cx="6496273" cy="46158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03491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I:\NtINV家族\figure3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620688"/>
            <a:ext cx="7439956" cy="4968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351962" y="6412686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S2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16629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I:\NtINV家族\figure5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9" y="175480"/>
            <a:ext cx="8933258" cy="56189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351962" y="6412686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S3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36473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dell\Desktop\INV0408\CWINV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38" t="4467" r="22554"/>
          <a:stretch/>
        </p:blipFill>
        <p:spPr bwMode="auto">
          <a:xfrm>
            <a:off x="827584" y="188640"/>
            <a:ext cx="7315200" cy="59465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351962" y="6412686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S4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0522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dell\Desktop\INV0408\Figure S2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31" r="21126"/>
          <a:stretch/>
        </p:blipFill>
        <p:spPr bwMode="auto">
          <a:xfrm>
            <a:off x="265140" y="425061"/>
            <a:ext cx="8878860" cy="57606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351962" y="6412686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S5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52699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dell\Desktop\INV0408\Figure S3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1" r="8442"/>
          <a:stretch/>
        </p:blipFill>
        <p:spPr bwMode="auto">
          <a:xfrm>
            <a:off x="1115616" y="764704"/>
            <a:ext cx="7037700" cy="49834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351962" y="6412686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S6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70454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7">
            <a:extLst>
              <a:ext uri="{FF2B5EF4-FFF2-40B4-BE49-F238E27FC236}">
                <a16:creationId xmlns:a16="http://schemas.microsoft.com/office/drawing/2014/main" id="{A57E0C30-D747-2641-AC8E-B02C75DCBDA7}"/>
              </a:ext>
            </a:extLst>
          </p:cNvPr>
          <p:cNvSpPr txBox="1"/>
          <p:nvPr/>
        </p:nvSpPr>
        <p:spPr>
          <a:xfrm>
            <a:off x="4351962" y="6412686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S7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1BB79EB-927E-B54B-A00E-5457F9DBC2ED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524" y="1916832"/>
            <a:ext cx="8568952" cy="2376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32838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4409695"/>
              </p:ext>
            </p:extLst>
          </p:nvPr>
        </p:nvGraphicFramePr>
        <p:xfrm>
          <a:off x="1591131" y="1371174"/>
          <a:ext cx="2016224" cy="18264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8170094"/>
              </p:ext>
            </p:extLst>
          </p:nvPr>
        </p:nvGraphicFramePr>
        <p:xfrm>
          <a:off x="6012793" y="1373484"/>
          <a:ext cx="2040085" cy="18722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8736115"/>
              </p:ext>
            </p:extLst>
          </p:nvPr>
        </p:nvGraphicFramePr>
        <p:xfrm>
          <a:off x="3635896" y="1373484"/>
          <a:ext cx="2077612" cy="17577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515696" y="1890075"/>
            <a:ext cx="20882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he content of chlorophyll a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g/g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4905312" y="1953220"/>
            <a:ext cx="20691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he content of total chlorophyll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g/g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351962" y="6412686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cs typeface="Arial" pitchFamily="34" charset="0"/>
              </a:rPr>
              <a:t>Figure S8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2627494" y="1917122"/>
            <a:ext cx="20882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he content of chlorophyll b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g/g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</p:spTree>
    <p:extLst>
      <p:ext uri="{BB962C8B-B14F-4D97-AF65-F5344CB8AC3E}">
        <p14:creationId xmlns:p14="http://schemas.microsoft.com/office/powerpoint/2010/main" val="28294655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96A894B-3805-D746-B816-8A8915A36E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36" y="1052736"/>
            <a:ext cx="7785100" cy="4292600"/>
          </a:xfrm>
          <a:prstGeom prst="rect">
            <a:avLst/>
          </a:prstGeom>
        </p:spPr>
      </p:pic>
      <p:sp>
        <p:nvSpPr>
          <p:cNvPr id="4" name="TextBox 14">
            <a:extLst>
              <a:ext uri="{FF2B5EF4-FFF2-40B4-BE49-F238E27FC236}">
                <a16:creationId xmlns:a16="http://schemas.microsoft.com/office/drawing/2014/main" id="{11D3C173-DCE3-7944-A408-CD2529B01E55}"/>
              </a:ext>
            </a:extLst>
          </p:cNvPr>
          <p:cNvSpPr txBox="1"/>
          <p:nvPr/>
        </p:nvSpPr>
        <p:spPr>
          <a:xfrm>
            <a:off x="4351962" y="6412686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>
                <a:latin typeface="Arial" pitchFamily="34" charset="0"/>
                <a:cs typeface="Arial" pitchFamily="34" charset="0"/>
              </a:rPr>
              <a:t>Figure S9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02033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7EDCC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87</TotalTime>
  <Words>50</Words>
  <Application>Microsoft Macintosh PowerPoint</Application>
  <PresentationFormat>全屏显示(4:3)</PresentationFormat>
  <Paragraphs>13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3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Microsoft Office User</cp:lastModifiedBy>
  <cp:revision>93</cp:revision>
  <dcterms:created xsi:type="dcterms:W3CDTF">2022-03-17T06:30:23Z</dcterms:created>
  <dcterms:modified xsi:type="dcterms:W3CDTF">2023-04-21T09:50:00Z</dcterms:modified>
</cp:coreProperties>
</file>